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81800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D5043-8196-4D2E-A691-621BFE1158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017A0-756C-402C-9BA3-88628CD85D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0EA4E-F18A-43C4-84F5-A268EC643A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DD45E-D134-45EC-821F-D75B348970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A4F50-6D6F-44A1-866A-EAB5478B9C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6D8EEA-BAB6-4263-8E8F-A0A6E99B9E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60D54-3004-4C35-9D57-DE38518F7F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2B99A9-F938-4385-A9B6-7FD6A8C9EB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0A9730-E558-4F55-9E72-0737FFE930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EB6F4-9CD7-43B3-A484-BA2D0F14FD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9F9A36-EE9F-4A6A-9200-278B8D07CD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F87194-6475-4684-AA76-9EC489E9C2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C840C8-B8EA-48B6-B8FC-1FD9FB13ECE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413000" y="1727280"/>
            <a:ext cx="3778200" cy="2560320"/>
            <a:chOff x="1413000" y="1727280"/>
            <a:chExt cx="3778200" cy="256032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0" t="0" r="0" b="28039"/>
            <a:stretch/>
          </p:blipFill>
          <p:spPr>
            <a:xfrm>
              <a:off x="1413000" y="1727280"/>
              <a:ext cx="1857240" cy="104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rcRect l="7016" t="0" r="0" b="28121"/>
            <a:stretch/>
          </p:blipFill>
          <p:spPr>
            <a:xfrm>
              <a:off x="3467160" y="1727280"/>
              <a:ext cx="1724040" cy="1039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/>
            <a:stretch/>
          </p:blipFill>
          <p:spPr>
            <a:xfrm>
              <a:off x="1413000" y="2846160"/>
              <a:ext cx="1849320" cy="14414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5" name=""/>
            <p:cNvGrpSpPr/>
            <p:nvPr/>
          </p:nvGrpSpPr>
          <p:grpSpPr>
            <a:xfrm>
              <a:off x="3284640" y="2855880"/>
              <a:ext cx="1854000" cy="1431720"/>
              <a:chOff x="3284640" y="2855880"/>
              <a:chExt cx="1854000" cy="1431720"/>
            </a:xfrm>
          </p:grpSpPr>
          <p:pic>
            <p:nvPicPr>
              <p:cNvPr id="46" name="" descr=""/>
              <p:cNvPicPr/>
              <p:nvPr/>
            </p:nvPicPr>
            <p:blipFill>
              <a:blip r:embed="rId4"/>
              <a:srcRect l="2643" t="0" r="0" b="0"/>
              <a:stretch/>
            </p:blipFill>
            <p:spPr>
              <a:xfrm>
                <a:off x="3349800" y="2855880"/>
                <a:ext cx="1788840" cy="1431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"/>
              <p:cNvSpPr/>
              <p:nvPr/>
            </p:nvSpPr>
            <p:spPr>
              <a:xfrm>
                <a:off x="3284640" y="2919240"/>
                <a:ext cx="144360" cy="863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8" name=""/>
          <p:cNvSpPr/>
          <p:nvPr/>
        </p:nvSpPr>
        <p:spPr>
          <a:xfrm>
            <a:off x="1125360" y="5006880"/>
            <a:ext cx="47516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Supplementary Figure S2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uantitative RT-PCR expression in different areas of the brain of the previously described downregulated genes in the hypothalamus of Mecp2 disrupted mice (Chahrour et al., Science 320: 1224-1229). White bars, wild-type mice; black bars, Mecp2 null mic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19T10:33:24Z</dcterms:created>
  <dc:creator>rgonzalezu</dc:creator>
  <dc:description/>
  <dc:language>en-US</dc:language>
  <cp:lastModifiedBy>h501xmeb</cp:lastModifiedBy>
  <dcterms:modified xsi:type="dcterms:W3CDTF">2008-10-22T08:08:49Z</dcterms:modified>
  <cp:revision>22</cp:revision>
  <dc:subject/>
  <dc:title>Diapositiva 1</dc:title>
</cp:coreProperties>
</file>